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64" r:id="rId4"/>
    <p:sldId id="265" r:id="rId5"/>
    <p:sldId id="266" r:id="rId6"/>
    <p:sldId id="267" r:id="rId7"/>
    <p:sldId id="260" r:id="rId8"/>
    <p:sldId id="268" r:id="rId9"/>
    <p:sldId id="262" r:id="rId10"/>
    <p:sldId id="263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42"/>
    <p:restoredTop sz="94694"/>
  </p:normalViewPr>
  <p:slideViewPr>
    <p:cSldViewPr snapToGrid="0" snapToObjects="1">
      <p:cViewPr varScale="1">
        <p:scale>
          <a:sx n="98" d="100"/>
          <a:sy n="98" d="100"/>
        </p:scale>
        <p:origin x="208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98AC3-2281-9743-9B69-9CDB07AF39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E23970-F997-C041-B0F1-5E291FD715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660B15-5897-ED4C-BAE9-1AC940EB5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C35812-E522-7243-AA94-7FE89950F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B600C-753E-B949-B973-73E77E8CD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18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8481-1134-7440-9E73-C00FCC411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6C777F-1A3B-514E-B13B-A03083E540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E5A8BA-0DFC-A543-8C31-322AB3FB8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90316-E1FC-0F42-8906-C04D16759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2DADF-C87B-8F4E-B795-2CD1BB7BF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37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134669-4614-E04B-AC7B-C96E34A6F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1493B5-C333-C643-AD00-2E4A42111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CCF21-B446-C241-860D-C2F3775CF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F0752-D487-BD43-9AC9-48DEA65A1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DA7C3-C37B-9347-9FDB-D20669348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83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89048-C327-DD4F-B355-154655689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F73491-2AA6-2C41-B9DE-FB63633FED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418B5-5198-E943-8C52-6F1DB9395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F46B30-D246-9D44-B6C5-148F6E6A1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C08A5-5479-134D-B9C7-FC78BD748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30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E6736-F8B2-8843-8CE5-2C2EDB364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85B263-3ACB-3F49-92B7-2BCCF0ECE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5591A-099F-6B4B-ACB9-7F39331E5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49D4F-BF9D-7A40-A6F0-F91EF210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163016-7B9E-714E-8A81-A196F6183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42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0DC66-7BF4-0748-A739-849A5823C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68B0F6-B82D-5F49-A7CF-51348BA98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B21A8C-8129-A44F-9744-47303EEE34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F9ADE3-1261-1441-9F51-27E6B2D8A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516574-01A0-224F-A511-0CC472B04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C57622-656B-744B-95E0-3B8F28E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9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31B6F-A978-CE46-869A-A229BA26BD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CDC9AB-F3DC-B644-830B-AEAF30102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5F11FA-1EA7-1248-90BD-FF5B72056E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5F4F25-2011-4A4F-9376-59C2CFCFDE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734C7-F327-5349-AF57-095362069D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72B7D3-BCBC-6F41-AECD-CB8F223F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E584CE-EAC7-5C40-A727-B1B68DDD6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B10B4C-E1E6-0147-A01C-E5486B1DC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36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D5AA0-EAB1-8F48-BCF8-BBC2087B4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73C422-439B-6440-9629-AD895000C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40F4AA-5EB1-F14D-809D-738077E98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D46968-AB53-7E4C-9D30-2DCAD2DBA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632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E25157-0F74-EE42-82B1-E8EAD897D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198EF-0710-3748-AD63-27191145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C40C9A-E25E-4C4B-8286-BD71A76E2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48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77D30-EAD5-9941-9856-4E7C2AB4A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F23C83-FDAC-1E45-AA4C-60DCFD126E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D00E5-816C-804A-AF2E-2315AAAD2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050761-E065-FA46-B35E-D75AB8FF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24DD24-9E76-CB4C-BBEF-49BB0A14E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C9D214-6DAD-7A46-8421-DB708B507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69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482A0-CF67-A442-B92F-97A0FB14A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793791-EB10-CD48-907D-1A3E660BFF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BD21D6-ABAD-1A4F-85AC-15EB121460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1A0094-7BC7-7B45-92AA-8F7940A46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1F4D8C-3BDC-8945-815A-6F8BA25BB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3B94CF-EB9D-4642-9A8A-8BD7273A1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9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5E1092-0207-824B-B043-7504BAAE7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68D305-2D73-8541-85D3-40E25A86F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D7D83-B2E8-6246-B9F8-F1CD4C1109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D7BD2-CCE9-C04F-9295-3606F3EF204F}" type="datetimeFigureOut">
              <a:rPr lang="en-US" smtClean="0"/>
              <a:t>7/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024BF-7208-194E-B14F-328EE0996C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3E3FA-D99E-1F40-B405-58A37E821C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hyperlink" Target="https://commons.wikimedia.org/wiki/File:Chest_Xray_PA_3-8-2010.png" TargetMode="Externa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hyperlink" Target="https://emsimcases.com/2015/11/24/dka/normal-post-intubation-cxr/" TargetMode="Externa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C6C0F-9115-4A4E-BA9C-29B5A2D9A82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58F201-7F3A-D247-94B3-D56049D6934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61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B50FD-C2F8-CF48-97A0-433B33CCE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A08D03-20AE-9A4E-86F5-2D6065674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ite blood count (WBC)		7.9 x 1000/mm</a:t>
            </a:r>
            <a:r>
              <a:rPr lang="en-US" baseline="30000" dirty="0"/>
              <a:t>3</a:t>
            </a:r>
            <a:endParaRPr lang="en-US" dirty="0"/>
          </a:p>
          <a:p>
            <a:r>
              <a:rPr lang="en-US" dirty="0"/>
              <a:t>Red Blood Count (RBC)			5.0 x 10</a:t>
            </a:r>
            <a:r>
              <a:rPr lang="en-US" baseline="30000" dirty="0"/>
              <a:t>6</a:t>
            </a:r>
            <a:r>
              <a:rPr lang="en-US" dirty="0"/>
              <a:t>/mm</a:t>
            </a:r>
            <a:r>
              <a:rPr lang="en-US" baseline="30000" dirty="0"/>
              <a:t>3</a:t>
            </a:r>
            <a:endParaRPr lang="en-US" dirty="0"/>
          </a:p>
          <a:p>
            <a:r>
              <a:rPr lang="en-US" dirty="0"/>
              <a:t>Hemoglobin (Hgb)			16.1 g/dL</a:t>
            </a:r>
          </a:p>
          <a:p>
            <a:r>
              <a:rPr lang="en-US" dirty="0"/>
              <a:t>Hematocrit (HCT)				45.6%</a:t>
            </a:r>
          </a:p>
          <a:p>
            <a:r>
              <a:rPr lang="en-US" dirty="0"/>
              <a:t>Mean Corpuscular Volume (MCV)	87</a:t>
            </a:r>
          </a:p>
          <a:p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				180 x 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4291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D62D8-1116-044A-8ED5-6BB889FA0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rterial Blood Ga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F4A2C-3C89-CF42-9C1C-B2F1F402FA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H						7.10</a:t>
            </a:r>
          </a:p>
          <a:p>
            <a:r>
              <a:rPr lang="en-US" dirty="0"/>
              <a:t>pCO2					20 mEq/L</a:t>
            </a:r>
          </a:p>
          <a:p>
            <a:r>
              <a:rPr lang="en-US" dirty="0"/>
              <a:t>pO2						92 mEq/L</a:t>
            </a:r>
          </a:p>
          <a:p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	14 mEq/L </a:t>
            </a:r>
          </a:p>
          <a:p>
            <a:r>
              <a:rPr lang="en-US" dirty="0"/>
              <a:t>Carboxyhemoglobin			8%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8664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i="1" dirty="0"/>
              <a:t>Lactic Acid					15.1 mmol/L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77861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yanide Lev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fontAlgn="base"/>
            <a:r>
              <a:rPr lang="en-US" i="1" dirty="0"/>
              <a:t>Cyanide Level				2.0 mcg/mL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6524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e Toxicology Scre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nl-NL" dirty="0" err="1"/>
              <a:t>Amphetamines</a:t>
            </a:r>
            <a:r>
              <a:rPr lang="nl-NL" dirty="0"/>
              <a:t>				</a:t>
            </a:r>
            <a:r>
              <a:rPr lang="nl-NL" i="1" dirty="0" err="1"/>
              <a:t>Negative</a:t>
            </a:r>
            <a:endParaRPr lang="en-US" dirty="0"/>
          </a:p>
          <a:p>
            <a:r>
              <a:rPr lang="nl-NL" dirty="0" err="1"/>
              <a:t>Barbiturates</a:t>
            </a:r>
            <a:r>
              <a:rPr lang="nl-NL" dirty="0"/>
              <a:t>				</a:t>
            </a:r>
            <a:r>
              <a:rPr lang="nl-NL" i="1" dirty="0" err="1"/>
              <a:t>Negative</a:t>
            </a:r>
            <a:endParaRPr lang="en-US" dirty="0"/>
          </a:p>
          <a:p>
            <a:r>
              <a:rPr lang="nl-NL" dirty="0"/>
              <a:t>Benzodiazepines				</a:t>
            </a:r>
            <a:r>
              <a:rPr lang="nl-NL" i="1" dirty="0" err="1"/>
              <a:t>Negative</a:t>
            </a:r>
            <a:endParaRPr lang="en-US" dirty="0"/>
          </a:p>
          <a:p>
            <a:r>
              <a:rPr lang="en-US" dirty="0"/>
              <a:t>Methadone				</a:t>
            </a:r>
            <a:r>
              <a:rPr lang="en-US" i="1" dirty="0"/>
              <a:t>Negative</a:t>
            </a:r>
            <a:endParaRPr lang="en-US" dirty="0"/>
          </a:p>
          <a:p>
            <a:r>
              <a:rPr lang="en-US" dirty="0"/>
              <a:t>Cocaine					</a:t>
            </a:r>
            <a:r>
              <a:rPr lang="en-US" i="1" dirty="0"/>
              <a:t>Negative</a:t>
            </a:r>
            <a:endParaRPr lang="en-US" dirty="0"/>
          </a:p>
          <a:p>
            <a:r>
              <a:rPr lang="en-US" dirty="0"/>
              <a:t>Opiates					</a:t>
            </a:r>
            <a:r>
              <a:rPr lang="en-US" i="1" dirty="0"/>
              <a:t>Negative</a:t>
            </a:r>
            <a:endParaRPr lang="en-US" dirty="0"/>
          </a:p>
          <a:p>
            <a:r>
              <a:rPr lang="en-US" dirty="0"/>
              <a:t>Phencyclidine (PCP)			</a:t>
            </a:r>
            <a:r>
              <a:rPr lang="en-US" i="1" dirty="0"/>
              <a:t>Negative</a:t>
            </a:r>
            <a:endParaRPr lang="en-US" dirty="0"/>
          </a:p>
          <a:p>
            <a:r>
              <a:rPr lang="pt-BR" dirty="0" err="1"/>
              <a:t>Tetrahydrocannabinol</a:t>
            </a:r>
            <a:r>
              <a:rPr lang="pt-BR" dirty="0"/>
              <a:t> (THC)		</a:t>
            </a:r>
            <a:r>
              <a:rPr lang="pt-BR" i="1" dirty="0"/>
              <a:t>Negative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73514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2031-51CB-F1D2-39B8-B578D1AE3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i="1" dirty="0" err="1"/>
              <a:t>Sinus</a:t>
            </a:r>
            <a:r>
              <a:rPr lang="pt-BR" i="1" dirty="0"/>
              <a:t> </a:t>
            </a:r>
            <a:r>
              <a:rPr lang="pt-BR" i="1" dirty="0" err="1"/>
              <a:t>Tachycardia</a:t>
            </a:r>
            <a:r>
              <a:rPr lang="pt-BR" i="1" dirty="0"/>
              <a:t> ECG 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EBF7D-BAF7-1FC7-364D-AA54D9D2B5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693229"/>
            <a:ext cx="10515600" cy="483734"/>
          </a:xfrm>
        </p:spPr>
        <p:txBody>
          <a:bodyPr>
            <a:normAutofit/>
          </a:bodyPr>
          <a:lstStyle/>
          <a:p>
            <a:r>
              <a:rPr lang="pt-BR" sz="1200" dirty="0"/>
              <a:t>(</a:t>
            </a:r>
            <a:r>
              <a:rPr lang="pt-BR" sz="1200" dirty="0" err="1"/>
              <a:t>example</a:t>
            </a:r>
            <a:r>
              <a:rPr lang="pt-BR" sz="1200" dirty="0"/>
              <a:t> 1). </a:t>
            </a:r>
            <a:r>
              <a:rPr lang="en-US" sz="1200" dirty="0"/>
              <a:t>Learn the Heart. https://</a:t>
            </a:r>
            <a:r>
              <a:rPr lang="en-US" sz="1200" dirty="0" err="1"/>
              <a:t>www.healio.com</a:t>
            </a:r>
            <a:r>
              <a:rPr lang="en-US" sz="1200" dirty="0"/>
              <a:t>/cardiology/learn-the-heart/</a:t>
            </a:r>
            <a:r>
              <a:rPr lang="en-US" sz="1200" dirty="0" err="1"/>
              <a:t>ecg</a:t>
            </a:r>
            <a:r>
              <a:rPr lang="en-US" sz="1200" dirty="0"/>
              <a:t>-review/</a:t>
            </a:r>
            <a:r>
              <a:rPr lang="en-US" sz="1200" dirty="0" err="1"/>
              <a:t>ecg</a:t>
            </a:r>
            <a:r>
              <a:rPr lang="en-US" sz="1200" dirty="0"/>
              <a:t>-archive/sinus-tachycardia-ecg-1. Published March 4, 2003. Accessed September 27, 2021. CC BY 4.0.</a:t>
            </a:r>
          </a:p>
          <a:p>
            <a:pPr marL="0" indent="0">
              <a:buNone/>
            </a:pPr>
            <a:endParaRPr lang="en-US" sz="1200" dirty="0"/>
          </a:p>
        </p:txBody>
      </p:sp>
      <p:pic>
        <p:nvPicPr>
          <p:cNvPr id="4" name="image8.jpg" descr="A picture containing chart&#10;&#10;Description automatically generated">
            <a:extLst>
              <a:ext uri="{FF2B5EF4-FFF2-40B4-BE49-F238E27FC236}">
                <a16:creationId xmlns:a16="http://schemas.microsoft.com/office/drawing/2014/main" id="{8F2E3679-4B5A-EF78-6FC1-09A49E8AFDC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124200" y="1682750"/>
            <a:ext cx="5943600" cy="3492500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1825039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2AD16-F9CF-9942-B7B6-707774FAB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itial Chest Radiograp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34397C-8B49-AA4A-81E4-B19F477780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176963"/>
            <a:ext cx="10515600" cy="363992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sz="1200" dirty="0" err="1"/>
              <a:t>Stillwaterising</a:t>
            </a:r>
            <a:r>
              <a:rPr lang="en-US" sz="1200" dirty="0"/>
              <a:t>. In Wikimedia Commons. </a:t>
            </a:r>
            <a:r>
              <a:rPr lang="en-US" sz="1200" dirty="0">
                <a:hlinkClick r:id="rId2"/>
              </a:rPr>
              <a:t>https://commons.wikimedia.org/wiki/File:Chest_Xray_PA_3-8-2010.png</a:t>
            </a:r>
            <a:r>
              <a:rPr lang="en-US" sz="1200" dirty="0"/>
              <a:t>. Published March 8, 2010. Accessed September 29, 2021. CC BY 1.0.</a:t>
            </a:r>
          </a:p>
          <a:p>
            <a:pPr marL="0" indent="0">
              <a:buNone/>
            </a:pPr>
            <a:endParaRPr lang="en-US" sz="1200" dirty="0"/>
          </a:p>
        </p:txBody>
      </p:sp>
      <p:pic>
        <p:nvPicPr>
          <p:cNvPr id="5" name="image2.jpg" descr="X-ray of a person's chest&#10;&#10;Description automatically generated with medium confidence">
            <a:extLst>
              <a:ext uri="{FF2B5EF4-FFF2-40B4-BE49-F238E27FC236}">
                <a16:creationId xmlns:a16="http://schemas.microsoft.com/office/drawing/2014/main" id="{C27F4833-0168-1351-3C48-ACA1E5BFDE86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3124200" y="1528763"/>
            <a:ext cx="5943600" cy="4648200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11565105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2AD16-F9CF-9942-B7B6-707774FAB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st-intubation Chest Radiograp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34397C-8B49-AA4A-81E4-B19F477780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176963"/>
            <a:ext cx="10515600" cy="363992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pt-BR" sz="1200" dirty="0"/>
              <a:t>In: EM Sim Cases. </a:t>
            </a:r>
            <a:r>
              <a:rPr lang="pt-BR" sz="1200" dirty="0">
                <a:hlinkClick r:id="rId2"/>
              </a:rPr>
              <a:t>https://emsimcases.com/2015/11/24/dka/normal-post-intubation-cxr/</a:t>
            </a:r>
            <a:r>
              <a:rPr lang="pt-BR" sz="1200" dirty="0"/>
              <a:t>. </a:t>
            </a:r>
            <a:r>
              <a:rPr lang="en-US" sz="1200" dirty="0"/>
              <a:t>Accessed September, 29, 2021. CC BY-SA 4.0.</a:t>
            </a:r>
          </a:p>
          <a:p>
            <a:pPr marL="0" indent="0">
              <a:buNone/>
            </a:pPr>
            <a:endParaRPr lang="en-US" sz="1200" dirty="0"/>
          </a:p>
        </p:txBody>
      </p:sp>
      <p:pic>
        <p:nvPicPr>
          <p:cNvPr id="4" name="image6.jpg" descr="X-ray of a person's chest&#10;&#10;Description automatically generated with medium confidence">
            <a:extLst>
              <a:ext uri="{FF2B5EF4-FFF2-40B4-BE49-F238E27FC236}">
                <a16:creationId xmlns:a16="http://schemas.microsoft.com/office/drawing/2014/main" id="{FE9286EC-60EB-E0B8-1B88-5CAE8B597193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3124200" y="1287463"/>
            <a:ext cx="5943600" cy="4889500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0363693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21C0E-D50D-874F-BED1-8BF190BBBB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rehensive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CB1529-5642-8446-87D6-0BAE8F34A3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34886"/>
            <a:ext cx="10515600" cy="4957989"/>
          </a:xfrm>
        </p:spPr>
        <p:txBody>
          <a:bodyPr>
            <a:noAutofit/>
          </a:bodyPr>
          <a:lstStyle/>
          <a:p>
            <a:pPr>
              <a:spcBef>
                <a:spcPts val="0"/>
              </a:spcBef>
            </a:pPr>
            <a:r>
              <a:rPr lang="en-US" sz="2400" dirty="0"/>
              <a:t>Sodium				140 mEq/L 	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Potassium				4.2 mEq/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Chloride				103 mEq/L 	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Blood Urea Nitrogen (BUN)		17 mg/dL 	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Creatinine (Cr)			1.05 mg/dL 	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Glucose				88 m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Calcium				9.9 m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Total bilirubin			0.6 m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Alkaline phosphatase		71 units/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Aspartate aminotransferase (AST)	16 units/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Alanine aminotransferase (ALT)	30 units/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Total Protein				7.1 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Albumin				4.5 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Phosphorous			3.2 mg/dL</a:t>
            </a:r>
          </a:p>
          <a:p>
            <a:pPr>
              <a:spcBef>
                <a:spcPts val="0"/>
              </a:spcBef>
            </a:pPr>
            <a:r>
              <a:rPr lang="en-US" sz="2400" dirty="0"/>
              <a:t>Magnesium				1.6 mEq/L</a:t>
            </a:r>
          </a:p>
          <a:p>
            <a:pPr fontAlgn="base">
              <a:spcBef>
                <a:spcPts val="0"/>
              </a:spcBef>
            </a:pP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515143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76</Words>
  <Application>Microsoft Macintosh PowerPoint</Application>
  <PresentationFormat>Widescreen</PresentationFormat>
  <Paragraphs>4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Stimulus Inventory</vt:lpstr>
      <vt:lpstr>Arterial Blood Gas</vt:lpstr>
      <vt:lpstr>Lactic Acid</vt:lpstr>
      <vt:lpstr>Cyanide Level</vt:lpstr>
      <vt:lpstr>Urine Toxicology Screen</vt:lpstr>
      <vt:lpstr>Sinus Tachycardia ECG </vt:lpstr>
      <vt:lpstr>Initial Chest Radiograph</vt:lpstr>
      <vt:lpstr>Post-intubation Chest Radiograph</vt:lpstr>
      <vt:lpstr>Comprehensive Metabolic Panel</vt:lpstr>
      <vt:lpstr>Complete Blood Cou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Alisa Wray</cp:lastModifiedBy>
  <cp:revision>16</cp:revision>
  <dcterms:created xsi:type="dcterms:W3CDTF">2021-10-07T03:47:09Z</dcterms:created>
  <dcterms:modified xsi:type="dcterms:W3CDTF">2022-07-08T04:13:58Z</dcterms:modified>
</cp:coreProperties>
</file>